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6143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4438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8832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085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62366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3085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5094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1448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6364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76695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66023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C2D464-BA34-42A7-8120-82324777CA91}" type="datetimeFigureOut">
              <a:rPr lang="it-IT" smtClean="0"/>
              <a:t>04/04/202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C37DEC-F1FB-47EC-89A3-1B99DCF4710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0625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452764" y="1205896"/>
            <a:ext cx="11301274" cy="42473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b="1" dirty="0" smtClean="0"/>
              <a:t>Figure S2</a:t>
            </a:r>
            <a:endParaRPr lang="en-US" b="1" dirty="0"/>
          </a:p>
          <a:p>
            <a:pPr algn="just">
              <a:lnSpc>
                <a:spcPct val="150000"/>
              </a:lnSpc>
            </a:pPr>
            <a:r>
              <a:rPr lang="en-US" dirty="0"/>
              <a:t>The figure displays the results of a NIPT in 3 women with multiple aneuploidies (A1-3), 3 single </a:t>
            </a:r>
            <a:r>
              <a:rPr lang="en-US" dirty="0" err="1"/>
              <a:t>aneuplodies</a:t>
            </a:r>
            <a:r>
              <a:rPr lang="en-US" dirty="0"/>
              <a:t> (B1, trisomy 18; B2, trisomy 13; B3, trisomy 21), and 3 negative tests (C1-3). The graph represents the chromosomes, with the x-axis indicating the chromosomal position in bins and the y-axis indicating the z-scores. The red line on the graph represents the z-score windowed method, which is a statistical method used to calculate the z-scores by analyzing multiple adjacent bins at once. The blue line on the graph represents the z-score individual bin method, which calculates the z-scores for each bin individually. The z-scores represent the deviation of the observed number of reads in a bin from the expected number of reads, and are used to detect chromosomal abnormalities. A z-score of zero represents no deviation, while positive or negative z-scores indicate an increase or decrease in the number of reads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868538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229850" y="2988953"/>
            <a:ext cx="1638299" cy="691392"/>
          </a:xfrm>
          <a:prstGeom prst="rect">
            <a:avLst/>
          </a:prstGeom>
        </p:spPr>
      </p:pic>
      <p:pic>
        <p:nvPicPr>
          <p:cNvPr id="9" name="Immagin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4214" y="160154"/>
            <a:ext cx="8863243" cy="6348990"/>
          </a:xfrm>
          <a:prstGeom prst="rect">
            <a:avLst/>
          </a:prstGeom>
        </p:spPr>
      </p:pic>
      <p:sp>
        <p:nvSpPr>
          <p:cNvPr id="10" name="CasellaDiTesto 9"/>
          <p:cNvSpPr txBox="1"/>
          <p:nvPr/>
        </p:nvSpPr>
        <p:spPr>
          <a:xfrm>
            <a:off x="171246" y="6400800"/>
            <a:ext cx="1581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Figure S2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4502376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</TotalTime>
  <Words>176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andro Ottaiano</dc:creator>
  <cp:lastModifiedBy>Alessandro Ottaiano</cp:lastModifiedBy>
  <cp:revision>16</cp:revision>
  <dcterms:created xsi:type="dcterms:W3CDTF">2023-03-20T12:59:21Z</dcterms:created>
  <dcterms:modified xsi:type="dcterms:W3CDTF">2023-04-04T09:16:26Z</dcterms:modified>
</cp:coreProperties>
</file>